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10" d="100"/>
          <a:sy n="110" d="100"/>
        </p:scale>
        <p:origin x="558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6D36B684-D74E-4135-A607-5129EC6E19B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xmlns="" id="{8EE416B7-A63A-4111-9591-394215EC0B8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8F78AE2C-F5A3-4419-BE9F-2F07FCE719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60D63-69F9-4C42-9198-2FD01798A751}" type="datetimeFigureOut">
              <a:rPr lang="zh-CN" altLang="en-US" smtClean="0"/>
              <a:t>2018/11/12 Monday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F7FB12E3-AC11-4B4C-8213-6DCAE33C56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FD70623F-59D5-4B68-85B0-4706DC7EF4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D5D67-8D2F-4DF1-8793-FC1DC3B891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378501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269C39FC-0C9E-4D69-8C99-109C58DB495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xmlns="" id="{60EAEC70-136D-4B5D-B831-6B71BBC6E5C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C74A9A0C-BF0C-4F68-9A4D-28175A9B30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60D63-69F9-4C42-9198-2FD01798A751}" type="datetimeFigureOut">
              <a:rPr lang="zh-CN" altLang="en-US" smtClean="0"/>
              <a:t>2018/11/12 Monday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ED4E6D1A-0BA6-4F26-91E1-65E88F6186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E5DCD7BA-E2A4-4496-981B-2C45F28825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D5D67-8D2F-4DF1-8793-FC1DC3B891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57020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xmlns="" id="{CDA3D5DA-6F3F-4C8C-A62C-27413C5E976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xmlns="" id="{4716FC49-FEEC-4609-AC3F-733FD6153EE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21069FBB-D4C0-48DA-BCD7-95DFAC102F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60D63-69F9-4C42-9198-2FD01798A751}" type="datetimeFigureOut">
              <a:rPr lang="zh-CN" altLang="en-US" smtClean="0"/>
              <a:t>2018/11/12 Monday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B79E14B5-3965-4C7D-863B-3ACEB9CB18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7971DCAF-E99F-4CC0-8EC1-7A4C52A13E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D5D67-8D2F-4DF1-8793-FC1DC3B891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206699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CCE5C7F0-0EE9-4BA3-A6D7-44EE013D8B8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xmlns="" id="{02092B3C-D2E3-426E-AC6E-46D3D42C8C1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2A70D3D5-F519-4EBC-B38C-A3C8F9C59A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60D63-69F9-4C42-9198-2FD01798A751}" type="datetimeFigureOut">
              <a:rPr lang="zh-CN" altLang="en-US" smtClean="0"/>
              <a:t>2018/11/12 Monday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018FB7F8-4DBE-4BA4-8C51-DCAE6AC936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63E807EE-B2DB-41A0-A974-46B366E2AD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D5D67-8D2F-4DF1-8793-FC1DC3B891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471929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7F38D831-FAA0-4BD2-B8BF-09BDCDA5679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xmlns="" id="{8882271F-311C-44F2-8AEA-C6BEDEA98D8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EFC10A58-A6F9-4605-A771-066BEB0D46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60D63-69F9-4C42-9198-2FD01798A751}" type="datetimeFigureOut">
              <a:rPr lang="zh-CN" altLang="en-US" smtClean="0"/>
              <a:t>2018/11/12 Monday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71E7AD6B-3D94-49A2-995E-0299794CD1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4648DAD5-EC24-4007-85DF-8D1D87BD73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D5D67-8D2F-4DF1-8793-FC1DC3B891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576123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BD29318F-EA23-45ED-9333-5A0D16DD24D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xmlns="" id="{2059D68D-55D8-4D18-B23E-242AED7155C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xmlns="" id="{3CB35A66-1CBB-4464-8482-B8F8072D737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xmlns="" id="{53D60BB6-1C68-4D05-BF9E-8E69F3DC49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60D63-69F9-4C42-9198-2FD01798A751}" type="datetimeFigureOut">
              <a:rPr lang="zh-CN" altLang="en-US" smtClean="0"/>
              <a:t>2018/11/12 Monday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xmlns="" id="{564063BE-FAA7-48CF-857C-D768D9EE3F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xmlns="" id="{54A383B8-6432-441B-8B4A-127B49B777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D5D67-8D2F-4DF1-8793-FC1DC3B891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436351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FFF8FB2C-F240-4A4A-8BF6-E97AB69338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xmlns="" id="{2217F7DF-7014-4081-83A6-10127BB2A22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xmlns="" id="{EEB2FE28-BCC7-416B-BE31-BED6C53C767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xmlns="" id="{CC62E9FF-CFAB-4DEE-8F0C-5E0FF67E0C8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xmlns="" id="{AFB7A299-682C-40B2-976F-D79613DB490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xmlns="" id="{AD06DE15-6D10-4FAE-B6AF-0C0FF4048A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60D63-69F9-4C42-9198-2FD01798A751}" type="datetimeFigureOut">
              <a:rPr lang="zh-CN" altLang="en-US" smtClean="0"/>
              <a:t>2018/11/12 Monday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xmlns="" id="{7560E965-EC8E-46F9-B8DC-BE9C48DC4E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xmlns="" id="{35537008-541E-4A72-98D7-D44CA81445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D5D67-8D2F-4DF1-8793-FC1DC3B891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009071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4C01D835-FA63-437E-8DD3-D46AD4E3836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xmlns="" id="{66711B21-ACE3-4158-B441-03351B87B0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60D63-69F9-4C42-9198-2FD01798A751}" type="datetimeFigureOut">
              <a:rPr lang="zh-CN" altLang="en-US" smtClean="0"/>
              <a:t>2018/11/12 Monday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xmlns="" id="{6328D6DE-852D-4F8C-BBBE-C2BA79A70B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xmlns="" id="{72C240B2-C1C3-42E6-A2A8-9E4424C035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D5D67-8D2F-4DF1-8793-FC1DC3B891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901383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xmlns="" id="{4D306D45-511E-4676-9627-55AA62F055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60D63-69F9-4C42-9198-2FD01798A751}" type="datetimeFigureOut">
              <a:rPr lang="zh-CN" altLang="en-US" smtClean="0"/>
              <a:t>2018/11/12 Monday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xmlns="" id="{F5C011B2-D8F6-4140-9625-4A68919059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xmlns="" id="{59F55D1D-B575-43AE-A2EF-E2CE94D246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D5D67-8D2F-4DF1-8793-FC1DC3B891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915522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0A3D088F-F2EB-49D8-8C95-43108320BE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xmlns="" id="{211F8027-3B79-499F-B591-D9C5CD7FE0E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xmlns="" id="{DDE820F0-9239-4641-BD94-4DDAF2820BA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xmlns="" id="{F019E457-B969-4F2D-92C2-A5834A37EF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60D63-69F9-4C42-9198-2FD01798A751}" type="datetimeFigureOut">
              <a:rPr lang="zh-CN" altLang="en-US" smtClean="0"/>
              <a:t>2018/11/12 Monday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xmlns="" id="{15197713-0B38-46FF-87CF-9A144394BA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xmlns="" id="{E7C123EA-B3C0-4027-9758-1A8E972267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D5D67-8D2F-4DF1-8793-FC1DC3B891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334527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D7E6CB0B-62A9-4C28-B2B8-0FDC6A63FE5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xmlns="" id="{27C059CF-10B3-4F90-BFF8-CA000694C54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xmlns="" id="{3B6CBCBF-42CC-4FD7-BD6F-296F3FFA259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xmlns="" id="{E8BDB99E-E832-43EC-AC9E-10F469E618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60D63-69F9-4C42-9198-2FD01798A751}" type="datetimeFigureOut">
              <a:rPr lang="zh-CN" altLang="en-US" smtClean="0"/>
              <a:t>2018/11/12 Monday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xmlns="" id="{04999BEC-A81A-4A6F-A0D1-21B0374FE9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xmlns="" id="{61EE7A6E-AFA0-46A0-BA9A-EEB14BC9CD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D5D67-8D2F-4DF1-8793-FC1DC3B891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702826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xmlns="" id="{C3A74913-CB06-4AF6-B5A8-42266D905F9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xmlns="" id="{804D80F4-6450-4613-90B3-D9C9380F6C3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0C4A5BE1-93D4-48B4-A9A8-325C60C1598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260D63-69F9-4C42-9198-2FD01798A751}" type="datetimeFigureOut">
              <a:rPr lang="zh-CN" altLang="en-US" smtClean="0"/>
              <a:t>2018/11/12 Monday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E85FE409-9EB5-4E3E-8C24-B6503621E25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80DE2126-6306-4744-B1C3-8F1236503FC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4D5D67-8D2F-4DF1-8793-FC1DC3B891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365480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xmlns="" id="{7A28B1EC-9815-4963-A20D-07482140627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72633" y="95416"/>
            <a:ext cx="8346010" cy="5897387"/>
          </a:xfrm>
          <a:prstGeom prst="rect">
            <a:avLst/>
          </a:prstGeom>
        </p:spPr>
      </p:pic>
      <p:sp>
        <p:nvSpPr>
          <p:cNvPr id="3" name="矩形 2">
            <a:extLst>
              <a:ext uri="{FF2B5EF4-FFF2-40B4-BE49-F238E27FC236}">
                <a16:creationId xmlns:a16="http://schemas.microsoft.com/office/drawing/2014/main" xmlns="" id="{7BFB88B3-3AAF-4563-BB9F-CED7149FDAC1}"/>
              </a:ext>
            </a:extLst>
          </p:cNvPr>
          <p:cNvSpPr/>
          <p:nvPr/>
        </p:nvSpPr>
        <p:spPr>
          <a:xfrm>
            <a:off x="2609245" y="6059941"/>
            <a:ext cx="6569261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2 Fig. KEGG pathway analysis identified starch and sucrose metabolism (ko00500) for DEGs between 5 DAP and 14DAP. 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d, green and blue indicate genes expression increase, decrease and mixed change at 14 DAP, respectively.</a:t>
            </a:r>
            <a:endParaRPr lang="zh-CN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455271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4</TotalTime>
  <Words>42</Words>
  <Application>Microsoft Office PowerPoint</Application>
  <PresentationFormat>宽屏</PresentationFormat>
  <Paragraphs>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i xiangyang</dc:creator>
  <cp:lastModifiedBy>微软用户</cp:lastModifiedBy>
  <cp:revision>11</cp:revision>
  <dcterms:created xsi:type="dcterms:W3CDTF">2018-10-07T03:25:32Z</dcterms:created>
  <dcterms:modified xsi:type="dcterms:W3CDTF">2018-11-11T16:25:47Z</dcterms:modified>
</cp:coreProperties>
</file>